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5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27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30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32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13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2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601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616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460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209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283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718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F8D0E-C4B9-4E21-8FA5-06C2D51DC84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A8F0F-FBFA-44A2-83B2-4907FB8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424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367143"/>
              </p:ext>
            </p:extLst>
          </p:nvPr>
        </p:nvGraphicFramePr>
        <p:xfrm>
          <a:off x="4552949" y="180975"/>
          <a:ext cx="7362828" cy="642937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40707">
                  <a:extLst>
                    <a:ext uri="{9D8B030D-6E8A-4147-A177-3AD203B41FA5}">
                      <a16:colId xmlns:a16="http://schemas.microsoft.com/office/drawing/2014/main" val="3799478068"/>
                    </a:ext>
                  </a:extLst>
                </a:gridCol>
                <a:gridCol w="1840707">
                  <a:extLst>
                    <a:ext uri="{9D8B030D-6E8A-4147-A177-3AD203B41FA5}">
                      <a16:colId xmlns:a16="http://schemas.microsoft.com/office/drawing/2014/main" val="1884475416"/>
                    </a:ext>
                  </a:extLst>
                </a:gridCol>
                <a:gridCol w="1840707">
                  <a:extLst>
                    <a:ext uri="{9D8B030D-6E8A-4147-A177-3AD203B41FA5}">
                      <a16:colId xmlns:a16="http://schemas.microsoft.com/office/drawing/2014/main" val="3636709967"/>
                    </a:ext>
                  </a:extLst>
                </a:gridCol>
                <a:gridCol w="1840707">
                  <a:extLst>
                    <a:ext uri="{9D8B030D-6E8A-4147-A177-3AD203B41FA5}">
                      <a16:colId xmlns:a16="http://schemas.microsoft.com/office/drawing/2014/main" val="2965894838"/>
                    </a:ext>
                  </a:extLst>
                </a:gridCol>
              </a:tblGrid>
              <a:tr h="578851">
                <a:tc>
                  <a:txBody>
                    <a:bodyPr/>
                    <a:lstStyle/>
                    <a:p>
                      <a:pPr algn="ctr"/>
                      <a:r>
                        <a:rPr lang="en-US" sz="1000" b="1" u="sng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</a:t>
                      </a: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u="sng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2</a:t>
                      </a: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u="sng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</a:t>
                      </a: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u="sng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4</a:t>
                      </a: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2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0622970"/>
                  </a:ext>
                </a:extLst>
              </a:tr>
              <a:tr h="776373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:30-8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duction</a:t>
                      </a:r>
                      <a:endParaRPr lang="en-US" sz="1000" b="1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:30-8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duction</a:t>
                      </a:r>
                      <a:endParaRPr lang="en-US" sz="1000" b="1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:30-8:3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sthma Lecture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:30-8:3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sthma Lecture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1870483"/>
                  </a:ext>
                </a:extLst>
              </a:tr>
              <a:tr h="776373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00-8:3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Test</a:t>
                      </a:r>
                      <a:endPara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00-8:3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Test</a:t>
                      </a:r>
                      <a:endPara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30-9:3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sthma Simulation</a:t>
                      </a: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30-9:3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sthma Simulation</a:t>
                      </a: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2885753"/>
                  </a:ext>
                </a:extLst>
              </a:tr>
              <a:tr h="915011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30-9:30</a:t>
                      </a:r>
                      <a:endParaRPr lang="en-US" sz="10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Bronchiolitis Lectur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:30-9:30</a:t>
                      </a:r>
                      <a:endParaRPr lang="en-US" sz="10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Bronchiolitis Lectur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:30-10:3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irway Lecture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:30-10:3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irway Lecture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5456834"/>
                  </a:ext>
                </a:extLst>
              </a:tr>
              <a:tr h="63773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:30-10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:30-10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:30-11:00</a:t>
                      </a:r>
                    </a:p>
                    <a:p>
                      <a:pPr algn="ctr"/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:30-11:00</a:t>
                      </a:r>
                    </a:p>
                    <a:p>
                      <a:pPr algn="ctr"/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0603096"/>
                  </a:ext>
                </a:extLst>
              </a:tr>
              <a:tr h="915011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:00-11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Bronchiolitis Small Group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:00-11:00</a:t>
                      </a:r>
                    </a:p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Bronchiolitis Small Group</a:t>
                      </a: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:00-12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irway Lab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:00-12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Airway Lab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4991917"/>
                  </a:ext>
                </a:extLst>
              </a:tr>
              <a:tr h="91501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:00-12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Pneumonia Lecture</a:t>
                      </a:r>
                      <a:endPara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:00-12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Pneumonia Lecture</a:t>
                      </a:r>
                      <a:endPara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:30-1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st-Tes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:30-1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st-Tes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532619"/>
                  </a:ext>
                </a:extLst>
              </a:tr>
              <a:tr h="91501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:00-1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Pneumonia Simulation</a:t>
                      </a: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:00-1:0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Pneumonia Simulation</a:t>
                      </a: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1971946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8546" y="2550695"/>
            <a:ext cx="308008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400" kern="1400" spc="-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diatric Emergencies Curriculum</a:t>
            </a:r>
          </a:p>
          <a:p>
            <a:pPr algn="ctr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iratory Emergencies</a:t>
            </a:r>
            <a:endParaRPr lang="en-US" sz="105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6087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Macintosh PowerPoint</Application>
  <PresentationFormat>Widescreen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0-08-27T03:31:38Z</dcterms:created>
  <dcterms:modified xsi:type="dcterms:W3CDTF">2021-04-13T04:00:01Z</dcterms:modified>
</cp:coreProperties>
</file>